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30" d="100"/>
          <a:sy n="30" d="100"/>
        </p:scale>
        <p:origin x="-25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E6425D-AE81-754E-80C1-52D955A70DC0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5D9285-D170-5A4F-A7FB-D634F93A5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23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31083D-CBB2-CB42-AB47-D62DEBA6FDE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051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044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614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138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848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982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81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625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20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508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53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594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591F3A-D4AF-1749-8030-941FC304761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1B9D2-3481-5943-BE85-B52EF16784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499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7082344"/>
              </p:ext>
            </p:extLst>
          </p:nvPr>
        </p:nvGraphicFramePr>
        <p:xfrm>
          <a:off x="447515" y="524905"/>
          <a:ext cx="7887014" cy="4450080"/>
        </p:xfrm>
        <a:graphic>
          <a:graphicData uri="http://schemas.openxmlformats.org/drawingml/2006/table">
            <a:tbl>
              <a:tblPr firstRow="1" bandRow="1">
                <a:effectLst/>
                <a:tableStyleId>{5940675A-B579-460E-94D1-54222C63F5DA}</a:tableStyleId>
              </a:tblPr>
              <a:tblGrid>
                <a:gridCol w="90200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0200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00.08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80.0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50.02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70.02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 smtClean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 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90.06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270.01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00.03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80.0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00.05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bbb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210.03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220.03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10.01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790.15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,bbb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20.02</a:t>
                      </a:r>
                      <a:endParaRPr lang="en-US" sz="1200" baseline="30000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ea typeface="ＭＳ 明朝"/>
                        <a:cs typeface="Times New Roman"/>
                        <a:sym typeface="Symbo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330.03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260.01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00.0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90.05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830.03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20.06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20.09</a:t>
                      </a:r>
                      <a:r>
                        <a:rPr lang="en-US" sz="120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</a:t>
                      </a:r>
                      <a:endParaRPr lang="en-US" sz="1200" baseline="300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00.08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8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860.09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570.08</a:t>
                      </a:r>
                      <a:r>
                        <a:rPr lang="en-US" sz="120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</a:t>
                      </a:r>
                      <a:endParaRPr lang="en-US" sz="1200" baseline="300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640.08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,bbb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90.09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780.07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40.04</a:t>
                      </a:r>
                      <a:r>
                        <a:rPr lang="en-US" sz="120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</a:t>
                      </a:r>
                      <a:endParaRPr lang="en-US" sz="1200" baseline="300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20.06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cccc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20.05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20.12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bbbb,cccc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-24190" y="18180"/>
            <a:ext cx="9317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/>
                <a:cs typeface="Times New Roman"/>
              </a:rPr>
              <a:t>S5 Table</a:t>
            </a:r>
            <a:endParaRPr lang="en-US" sz="16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24190" y="5294445"/>
            <a:ext cx="719666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/>
                <a:cs typeface="Times New Roman"/>
              </a:rPr>
              <a:t>S5 Table.</a:t>
            </a:r>
            <a:r>
              <a:rPr lang="en-US" sz="1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sz="1400" b="1" dirty="0">
                <a:latin typeface="Times New Roman"/>
                <a:cs typeface="Times New Roman"/>
              </a:rPr>
              <a:t>Comparison of m</a:t>
            </a:r>
            <a:r>
              <a:rPr lang="en-US" sz="1400" b="1" dirty="0" smtClean="0">
                <a:latin typeface="Times New Roman"/>
                <a:cs typeface="Times New Roman"/>
              </a:rPr>
              <a:t>iR-124 levels </a:t>
            </a:r>
            <a:r>
              <a:rPr lang="en-US" sz="1400" b="1" dirty="0" smtClean="0">
                <a:latin typeface="Times New Roman"/>
                <a:cs typeface="Times New Roman"/>
              </a:rPr>
              <a:t>in </a:t>
            </a:r>
            <a:r>
              <a:rPr lang="en-US" sz="1400" b="1" dirty="0">
                <a:latin typeface="Times New Roman"/>
                <a:cs typeface="Times New Roman"/>
              </a:rPr>
              <a:t>unstressed </a:t>
            </a:r>
            <a:r>
              <a:rPr lang="en-US" sz="1400" b="1" i="1" dirty="0" smtClean="0">
                <a:latin typeface="Times New Roman"/>
                <a:cs typeface="Times New Roman"/>
              </a:rPr>
              <a:t>vs. </a:t>
            </a:r>
            <a:r>
              <a:rPr lang="en-US" sz="1400" b="1" dirty="0">
                <a:latin typeface="Times New Roman"/>
                <a:cs typeface="Times New Roman"/>
              </a:rPr>
              <a:t>stressed </a:t>
            </a:r>
            <a:r>
              <a:rPr lang="en-US" sz="1400" b="1" dirty="0" smtClean="0">
                <a:latin typeface="Times New Roman"/>
                <a:cs typeface="Times New Roman"/>
              </a:rPr>
              <a:t>mice. </a:t>
            </a:r>
            <a:endParaRPr lang="en-US" sz="1400" dirty="0">
              <a:latin typeface="Times New Roman"/>
              <a:cs typeface="Times New Roman"/>
            </a:endParaRPr>
          </a:p>
          <a:p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192320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6</Words>
  <Application>Microsoft Macintosh PowerPoint</Application>
  <PresentationFormat>On-screen Show (4:3)</PresentationFormat>
  <Paragraphs>7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3-05T13:41:03Z</dcterms:created>
  <dcterms:modified xsi:type="dcterms:W3CDTF">2018-03-05T13:41:23Z</dcterms:modified>
</cp:coreProperties>
</file>